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2" d="100"/>
          <a:sy n="122" d="100"/>
        </p:scale>
        <p:origin x="-127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269A8A-E269-4250-B07E-6864177E9D89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AD04D4-E8EC-4CED-9B67-9958A444C2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1561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new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3E7DAC-65E9-6847-BC86-F4065EDC4AF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3739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059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95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974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323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586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158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12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808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729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666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336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AB515-EC3A-43DA-A99D-4B17ED70C187}" type="datetimeFigureOut">
              <a:rPr lang="en-US" smtClean="0"/>
              <a:t>12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C2C764-856E-425F-ABC1-C31AD6474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802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045154" y="2419507"/>
            <a:ext cx="6400800" cy="38404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562187" y="2408905"/>
            <a:ext cx="861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Acti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577128" y="1965350"/>
            <a:ext cx="799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AG2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 rot="18035667">
            <a:off x="881672" y="1339816"/>
            <a:ext cx="88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K-ES-1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 rot="18035667">
            <a:off x="1506637" y="1328356"/>
            <a:ext cx="980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87-MG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 rot="18035667">
            <a:off x="3526032" y="1360800"/>
            <a:ext cx="7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xPC3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 rot="18035667">
            <a:off x="4143513" y="1307469"/>
            <a:ext cx="959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pan-1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 rot="18035667">
            <a:off x="4787509" y="1308754"/>
            <a:ext cx="959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pan-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 rot="18035667">
            <a:off x="5436027" y="1295098"/>
            <a:ext cx="977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FPAC-1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 rot="18035667">
            <a:off x="6100940" y="131790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766t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 rot="18035667">
            <a:off x="6619871" y="1182636"/>
            <a:ext cx="11966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iaPaCa-2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 rot="18035667">
            <a:off x="2247004" y="1429081"/>
            <a:ext cx="66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375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rot="18035667">
            <a:off x="2857695" y="1333496"/>
            <a:ext cx="854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SPC-1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>
            <a:off x="7562187" y="4573378"/>
            <a:ext cx="799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AG2</a:t>
            </a:r>
            <a:endParaRPr lang="en-US" dirty="0"/>
          </a:p>
        </p:txBody>
      </p:sp>
      <p:sp>
        <p:nvSpPr>
          <p:cNvPr id="65" name="TextBox 64"/>
          <p:cNvSpPr txBox="1"/>
          <p:nvPr/>
        </p:nvSpPr>
        <p:spPr>
          <a:xfrm rot="18035667">
            <a:off x="1067935" y="3924609"/>
            <a:ext cx="88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K-ES-1</a:t>
            </a:r>
            <a:endParaRPr lang="en-US" dirty="0"/>
          </a:p>
        </p:txBody>
      </p:sp>
      <p:sp>
        <p:nvSpPr>
          <p:cNvPr id="66" name="TextBox 65"/>
          <p:cNvSpPr txBox="1"/>
          <p:nvPr/>
        </p:nvSpPr>
        <p:spPr>
          <a:xfrm rot="18035667">
            <a:off x="1657221" y="3898031"/>
            <a:ext cx="980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87-MG</a:t>
            </a:r>
            <a:endParaRPr lang="en-US" dirty="0"/>
          </a:p>
        </p:txBody>
      </p:sp>
      <p:sp>
        <p:nvSpPr>
          <p:cNvPr id="67" name="TextBox 66"/>
          <p:cNvSpPr txBox="1"/>
          <p:nvPr/>
        </p:nvSpPr>
        <p:spPr>
          <a:xfrm rot="18035667">
            <a:off x="3490878" y="3779295"/>
            <a:ext cx="121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Panc</a:t>
            </a:r>
            <a:r>
              <a:rPr lang="en-US" dirty="0" smtClean="0"/>
              <a:t> 02.03</a:t>
            </a:r>
            <a:endParaRPr lang="en-US" dirty="0"/>
          </a:p>
        </p:txBody>
      </p:sp>
      <p:sp>
        <p:nvSpPr>
          <p:cNvPr id="68" name="TextBox 67"/>
          <p:cNvSpPr txBox="1"/>
          <p:nvPr/>
        </p:nvSpPr>
        <p:spPr>
          <a:xfrm rot="18035667">
            <a:off x="4090057" y="3771672"/>
            <a:ext cx="121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Panc</a:t>
            </a:r>
            <a:r>
              <a:rPr lang="en-US" dirty="0" smtClean="0"/>
              <a:t> 03.27</a:t>
            </a:r>
            <a:endParaRPr lang="en-US" dirty="0"/>
          </a:p>
        </p:txBody>
      </p:sp>
      <p:sp>
        <p:nvSpPr>
          <p:cNvPr id="69" name="TextBox 68"/>
          <p:cNvSpPr txBox="1"/>
          <p:nvPr/>
        </p:nvSpPr>
        <p:spPr>
          <a:xfrm rot="18035667">
            <a:off x="4681260" y="3788252"/>
            <a:ext cx="121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Panc</a:t>
            </a:r>
            <a:r>
              <a:rPr lang="en-US" dirty="0" smtClean="0"/>
              <a:t> 04.03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 rot="18035667">
            <a:off x="5511880" y="3986602"/>
            <a:ext cx="705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L-45</a:t>
            </a:r>
            <a:endParaRPr lang="en-US" dirty="0"/>
          </a:p>
        </p:txBody>
      </p:sp>
      <p:sp>
        <p:nvSpPr>
          <p:cNvPr id="72" name="TextBox 71"/>
          <p:cNvSpPr txBox="1"/>
          <p:nvPr/>
        </p:nvSpPr>
        <p:spPr>
          <a:xfrm rot="18035667">
            <a:off x="6039002" y="3902693"/>
            <a:ext cx="9650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86.86</a:t>
            </a:r>
            <a:endParaRPr lang="en-US" dirty="0"/>
          </a:p>
        </p:txBody>
      </p:sp>
      <p:sp>
        <p:nvSpPr>
          <p:cNvPr id="74" name="TextBox 73"/>
          <p:cNvSpPr txBox="1"/>
          <p:nvPr/>
        </p:nvSpPr>
        <p:spPr>
          <a:xfrm rot="18035667">
            <a:off x="2380655" y="3998756"/>
            <a:ext cx="66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375</a:t>
            </a:r>
            <a:endParaRPr lang="en-US" dirty="0"/>
          </a:p>
        </p:txBody>
      </p:sp>
      <p:sp>
        <p:nvSpPr>
          <p:cNvPr id="75" name="TextBox 74"/>
          <p:cNvSpPr txBox="1"/>
          <p:nvPr/>
        </p:nvSpPr>
        <p:spPr>
          <a:xfrm rot="18035667">
            <a:off x="2948957" y="3903348"/>
            <a:ext cx="897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NC-1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036521" y="2417933"/>
            <a:ext cx="6400800" cy="38404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57150" cmpd="sng">
                <a:solidFill>
                  <a:srgbClr val="000000"/>
                </a:solidFill>
              </a:ln>
              <a:noFill/>
            </a:endParaRPr>
          </a:p>
        </p:txBody>
      </p:sp>
      <p:pic>
        <p:nvPicPr>
          <p:cNvPr id="14" name="Picture 13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39582" y="5205103"/>
            <a:ext cx="6400800" cy="411480"/>
          </a:xfrm>
          <a:prstGeom prst="rect">
            <a:avLst/>
          </a:prstGeom>
        </p:spPr>
      </p:pic>
      <p:sp>
        <p:nvSpPr>
          <p:cNvPr id="79" name="Rectangle 78"/>
          <p:cNvSpPr/>
          <p:nvPr/>
        </p:nvSpPr>
        <p:spPr>
          <a:xfrm>
            <a:off x="1045154" y="5205103"/>
            <a:ext cx="6400800" cy="42062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57150" cmpd="sng">
                <a:solidFill>
                  <a:srgbClr val="000000"/>
                </a:solidFill>
              </a:ln>
              <a:noFill/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1045154" y="4563358"/>
            <a:ext cx="6400800" cy="42062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57150" cmpd="sng">
                <a:solidFill>
                  <a:srgbClr val="000000"/>
                </a:solidFill>
              </a:ln>
              <a:noFill/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1045154" y="1917571"/>
            <a:ext cx="6400800" cy="41148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57150" cmpd="sng">
                <a:solidFill>
                  <a:srgbClr val="000000"/>
                </a:solidFill>
              </a:ln>
              <a:noFill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7562187" y="5247251"/>
            <a:ext cx="861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Actin</a:t>
            </a:r>
            <a:endParaRPr lang="en-US" dirty="0"/>
          </a:p>
        </p:txBody>
      </p:sp>
      <p:pic>
        <p:nvPicPr>
          <p:cNvPr id="21" name="Picture 20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050235" y="4566114"/>
            <a:ext cx="6391656" cy="402569"/>
          </a:xfrm>
          <a:prstGeom prst="rect">
            <a:avLst/>
          </a:prstGeom>
        </p:spPr>
      </p:pic>
      <p:pic>
        <p:nvPicPr>
          <p:cNvPr id="22" name="Picture 21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037859" y="1923202"/>
            <a:ext cx="6400800" cy="41148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556470" y="6579969"/>
            <a:ext cx="2582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vers et al., Supplemental Figure 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2687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arrett</dc:creator>
  <cp:lastModifiedBy>Michael Barrett</cp:lastModifiedBy>
  <cp:revision>1</cp:revision>
  <dcterms:created xsi:type="dcterms:W3CDTF">2013-12-16T17:35:37Z</dcterms:created>
  <dcterms:modified xsi:type="dcterms:W3CDTF">2013-12-16T17:36:16Z</dcterms:modified>
</cp:coreProperties>
</file>